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FFFF00"/>
    <a:srgbClr val="FF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37073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8334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21568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6806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9401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25497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2939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20691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2427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928344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4834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72EDF-F70C-42ED-BE39-A849192ED4DE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EDE39-981C-436C-9290-7A49C69C78E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13586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3678123" y="837507"/>
            <a:ext cx="1796437" cy="3719463"/>
            <a:chOff x="3591498" y="1149697"/>
            <a:chExt cx="1796437" cy="3719463"/>
          </a:xfrm>
        </p:grpSpPr>
        <p:pic>
          <p:nvPicPr>
            <p:cNvPr id="1026" name="Picture 2" descr="H:\admin 2014-04-27 07hr 18min VIVEK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13000"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26" t="2856" r="42628" b="16325"/>
            <a:stretch/>
          </p:blipFill>
          <p:spPr bwMode="auto">
            <a:xfrm>
              <a:off x="3591498" y="1412776"/>
              <a:ext cx="1796437" cy="345638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3722094" y="1149697"/>
              <a:ext cx="16658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C    E      H        X</a:t>
              </a:r>
              <a:endParaRPr lang="en-I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H="1">
              <a:off x="4264975" y="2564904"/>
              <a:ext cx="216024" cy="203434"/>
            </a:xfrm>
            <a:prstGeom prst="straightConnector1">
              <a:avLst/>
            </a:prstGeom>
            <a:ln>
              <a:solidFill>
                <a:srgbClr val="FFFF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 flipH="1" flipV="1">
              <a:off x="4372407" y="2984362"/>
              <a:ext cx="216024" cy="156606"/>
            </a:xfrm>
            <a:prstGeom prst="straightConnector1">
              <a:avLst/>
            </a:prstGeom>
            <a:ln>
              <a:solidFill>
                <a:srgbClr val="FFFF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Box 5"/>
          <p:cNvSpPr txBox="1"/>
          <p:nvPr/>
        </p:nvSpPr>
        <p:spPr>
          <a:xfrm>
            <a:off x="3059833" y="4653136"/>
            <a:ext cx="29523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Figure S2:</a:t>
            </a:r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200" b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outhern hybridisation of </a:t>
            </a:r>
            <a:r>
              <a:rPr lang="en-IN" sz="1200" b="1" i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. brachiata </a:t>
            </a:r>
            <a:r>
              <a:rPr lang="en-IN" sz="1200" b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genome to determine </a:t>
            </a:r>
            <a:r>
              <a:rPr lang="en-IN" sz="1200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copy number of </a:t>
            </a:r>
            <a:r>
              <a:rPr lang="en-IN" sz="1200" b="1" i="1" dirty="0" err="1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SbASR</a:t>
            </a:r>
            <a:r>
              <a:rPr lang="en-IN" sz="1200" b="1" i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200" b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gene.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Lane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PC: Positive control </a:t>
            </a:r>
            <a:r>
              <a:rPr lang="en-IN" sz="1200" i="1" dirty="0" smtClean="0">
                <a:latin typeface="Times New Roman" pitchFamily="18" charset="0"/>
                <a:cs typeface="Times New Roman" pitchFamily="18" charset="0"/>
              </a:rPr>
              <a:t>SbASR-1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cloned vector; Lane E, H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X: Genomic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DNA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digested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IN" sz="1200" i="1" dirty="0" err="1">
                <a:latin typeface="Times New Roman" pitchFamily="18" charset="0"/>
                <a:cs typeface="Times New Roman" pitchFamily="18" charset="0"/>
              </a:rPr>
              <a:t>EcoR</a:t>
            </a:r>
            <a:r>
              <a:rPr lang="en-IN" sz="1200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200" i="1" dirty="0" err="1">
                <a:latin typeface="Times New Roman" pitchFamily="18" charset="0"/>
                <a:cs typeface="Times New Roman" pitchFamily="18" charset="0"/>
              </a:rPr>
              <a:t>Hind</a:t>
            </a:r>
            <a:r>
              <a:rPr lang="en-IN" sz="1200" dirty="0" err="1">
                <a:latin typeface="Times New Roman" pitchFamily="18" charset="0"/>
                <a:cs typeface="Times New Roman" pitchFamily="18" charset="0"/>
              </a:rPr>
              <a:t>III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IN" sz="1200" i="1" dirty="0" err="1">
                <a:latin typeface="Times New Roman" pitchFamily="18" charset="0"/>
                <a:cs typeface="Times New Roman" pitchFamily="18" charset="0"/>
              </a:rPr>
              <a:t>Xba</a:t>
            </a:r>
            <a:r>
              <a:rPr lang="en-IN" sz="1200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 enzymes,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respectively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0933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5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10</cp:revision>
  <dcterms:created xsi:type="dcterms:W3CDTF">2014-06-22T04:55:56Z</dcterms:created>
  <dcterms:modified xsi:type="dcterms:W3CDTF">2015-04-27T06:15:33Z</dcterms:modified>
</cp:coreProperties>
</file>